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408" r:id="rId4"/>
    <p:sldId id="259" r:id="rId5"/>
    <p:sldId id="261" r:id="rId6"/>
    <p:sldId id="260" r:id="rId7"/>
    <p:sldId id="262" r:id="rId8"/>
    <p:sldId id="263" r:id="rId9"/>
    <p:sldId id="264" r:id="rId10"/>
    <p:sldId id="284" r:id="rId11"/>
    <p:sldId id="265" r:id="rId12"/>
    <p:sldId id="266" r:id="rId13"/>
    <p:sldId id="267" r:id="rId14"/>
    <p:sldId id="268" r:id="rId15"/>
    <p:sldId id="269" r:id="rId16"/>
    <p:sldId id="270" r:id="rId17"/>
    <p:sldId id="374" r:id="rId18"/>
    <p:sldId id="383" r:id="rId19"/>
    <p:sldId id="384" r:id="rId20"/>
    <p:sldId id="385" r:id="rId21"/>
    <p:sldId id="386" r:id="rId22"/>
    <p:sldId id="387" r:id="rId23"/>
    <p:sldId id="388" r:id="rId24"/>
    <p:sldId id="389" r:id="rId25"/>
    <p:sldId id="390" r:id="rId26"/>
    <p:sldId id="375" r:id="rId27"/>
    <p:sldId id="376" r:id="rId28"/>
    <p:sldId id="377" r:id="rId29"/>
    <p:sldId id="378" r:id="rId30"/>
    <p:sldId id="379" r:id="rId31"/>
    <p:sldId id="380" r:id="rId32"/>
    <p:sldId id="381" r:id="rId33"/>
    <p:sldId id="382" r:id="rId34"/>
    <p:sldId id="285" r:id="rId35"/>
    <p:sldId id="321" r:id="rId36"/>
    <p:sldId id="322" r:id="rId37"/>
    <p:sldId id="323" r:id="rId38"/>
    <p:sldId id="324" r:id="rId39"/>
    <p:sldId id="325" r:id="rId40"/>
    <p:sldId id="326" r:id="rId41"/>
    <p:sldId id="327" r:id="rId42"/>
    <p:sldId id="328" r:id="rId43"/>
    <p:sldId id="313" r:id="rId44"/>
    <p:sldId id="314" r:id="rId45"/>
    <p:sldId id="315" r:id="rId46"/>
    <p:sldId id="316" r:id="rId47"/>
    <p:sldId id="317" r:id="rId48"/>
    <p:sldId id="318" r:id="rId49"/>
    <p:sldId id="319" r:id="rId50"/>
    <p:sldId id="320" r:id="rId51"/>
    <p:sldId id="302" r:id="rId52"/>
    <p:sldId id="271" r:id="rId53"/>
    <p:sldId id="303" r:id="rId54"/>
    <p:sldId id="272" r:id="rId55"/>
    <p:sldId id="304" r:id="rId56"/>
    <p:sldId id="305" r:id="rId57"/>
    <p:sldId id="306" r:id="rId58"/>
    <p:sldId id="307" r:id="rId59"/>
    <p:sldId id="308" r:id="rId60"/>
    <p:sldId id="309" r:id="rId61"/>
    <p:sldId id="310" r:id="rId62"/>
    <p:sldId id="311" r:id="rId63"/>
    <p:sldId id="312" r:id="rId64"/>
    <p:sldId id="329" r:id="rId65"/>
    <p:sldId id="273" r:id="rId66"/>
    <p:sldId id="330" r:id="rId67"/>
    <p:sldId id="337" r:id="rId68"/>
    <p:sldId id="338" r:id="rId69"/>
    <p:sldId id="335" r:id="rId70"/>
    <p:sldId id="336" r:id="rId71"/>
    <p:sldId id="333" r:id="rId72"/>
    <p:sldId id="334" r:id="rId73"/>
    <p:sldId id="331" r:id="rId74"/>
    <p:sldId id="332" r:id="rId75"/>
    <p:sldId id="341" r:id="rId76"/>
    <p:sldId id="342" r:id="rId77"/>
    <p:sldId id="339" r:id="rId78"/>
    <p:sldId id="340" r:id="rId79"/>
    <p:sldId id="345" r:id="rId80"/>
    <p:sldId id="346" r:id="rId81"/>
    <p:sldId id="343" r:id="rId82"/>
    <p:sldId id="344" r:id="rId83"/>
    <p:sldId id="391" r:id="rId84"/>
    <p:sldId id="398" r:id="rId85"/>
    <p:sldId id="399" r:id="rId86"/>
    <p:sldId id="396" r:id="rId87"/>
    <p:sldId id="397" r:id="rId88"/>
    <p:sldId id="394" r:id="rId89"/>
    <p:sldId id="395" r:id="rId90"/>
    <p:sldId id="392" r:id="rId91"/>
    <p:sldId id="393" r:id="rId92"/>
    <p:sldId id="402" r:id="rId93"/>
    <p:sldId id="403" r:id="rId94"/>
    <p:sldId id="400" r:id="rId95"/>
    <p:sldId id="401" r:id="rId96"/>
    <p:sldId id="406" r:id="rId97"/>
    <p:sldId id="407" r:id="rId98"/>
    <p:sldId id="404" r:id="rId99"/>
    <p:sldId id="405" r:id="rId100"/>
    <p:sldId id="347" r:id="rId101"/>
    <p:sldId id="351" r:id="rId102"/>
    <p:sldId id="350" r:id="rId103"/>
    <p:sldId id="349" r:id="rId104"/>
    <p:sldId id="348" r:id="rId105"/>
    <p:sldId id="353" r:id="rId106"/>
    <p:sldId id="352" r:id="rId107"/>
    <p:sldId id="355" r:id="rId108"/>
    <p:sldId id="354" r:id="rId109"/>
    <p:sldId id="357" r:id="rId110"/>
    <p:sldId id="361" r:id="rId111"/>
    <p:sldId id="360" r:id="rId112"/>
    <p:sldId id="359" r:id="rId113"/>
    <p:sldId id="358" r:id="rId114"/>
    <p:sldId id="363" r:id="rId115"/>
    <p:sldId id="362" r:id="rId116"/>
    <p:sldId id="365" r:id="rId117"/>
    <p:sldId id="364" r:id="rId118"/>
    <p:sldId id="367" r:id="rId119"/>
    <p:sldId id="276" r:id="rId120"/>
    <p:sldId id="368" r:id="rId121"/>
    <p:sldId id="369" r:id="rId122"/>
    <p:sldId id="370" r:id="rId123"/>
    <p:sldId id="371" r:id="rId124"/>
    <p:sldId id="372" r:id="rId125"/>
    <p:sldId id="373" r:id="rId1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58"/>
    <p:restoredTop sz="96327"/>
  </p:normalViewPr>
  <p:slideViewPr>
    <p:cSldViewPr snapToGrid="0">
      <p:cViewPr varScale="1">
        <p:scale>
          <a:sx n="140" d="100"/>
          <a:sy n="140" d="100"/>
        </p:scale>
        <p:origin x="216" y="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7" Type="http://schemas.openxmlformats.org/officeDocument/2006/relationships/slide" Target="slides/slide116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slide" Target="slides/slide83.xml"/><Relationship Id="rId89" Type="http://schemas.openxmlformats.org/officeDocument/2006/relationships/slide" Target="slides/slide88.xml"/><Relationship Id="rId112" Type="http://schemas.openxmlformats.org/officeDocument/2006/relationships/slide" Target="slides/slide111.xml"/><Relationship Id="rId16" Type="http://schemas.openxmlformats.org/officeDocument/2006/relationships/slide" Target="slides/slide15.xml"/><Relationship Id="rId107" Type="http://schemas.openxmlformats.org/officeDocument/2006/relationships/slide" Target="slides/slide106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102" Type="http://schemas.openxmlformats.org/officeDocument/2006/relationships/slide" Target="slides/slide101.xml"/><Relationship Id="rId123" Type="http://schemas.openxmlformats.org/officeDocument/2006/relationships/slide" Target="slides/slide122.xml"/><Relationship Id="rId128" Type="http://schemas.openxmlformats.org/officeDocument/2006/relationships/viewProps" Target="viewProps.xml"/><Relationship Id="rId5" Type="http://schemas.openxmlformats.org/officeDocument/2006/relationships/slide" Target="slides/slide4.xml"/><Relationship Id="rId90" Type="http://schemas.openxmlformats.org/officeDocument/2006/relationships/slide" Target="slides/slide89.xml"/><Relationship Id="rId95" Type="http://schemas.openxmlformats.org/officeDocument/2006/relationships/slide" Target="slides/slide94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113" Type="http://schemas.openxmlformats.org/officeDocument/2006/relationships/slide" Target="slides/slide112.xml"/><Relationship Id="rId118" Type="http://schemas.openxmlformats.org/officeDocument/2006/relationships/slide" Target="slides/slide117.xml"/><Relationship Id="rId80" Type="http://schemas.openxmlformats.org/officeDocument/2006/relationships/slide" Target="slides/slide79.xml"/><Relationship Id="rId85" Type="http://schemas.openxmlformats.org/officeDocument/2006/relationships/slide" Target="slides/slide84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59" Type="http://schemas.openxmlformats.org/officeDocument/2006/relationships/slide" Target="slides/slide58.xml"/><Relationship Id="rId103" Type="http://schemas.openxmlformats.org/officeDocument/2006/relationships/slide" Target="slides/slide102.xml"/><Relationship Id="rId108" Type="http://schemas.openxmlformats.org/officeDocument/2006/relationships/slide" Target="slides/slide107.xml"/><Relationship Id="rId124" Type="http://schemas.openxmlformats.org/officeDocument/2006/relationships/slide" Target="slides/slide123.xml"/><Relationship Id="rId129" Type="http://schemas.openxmlformats.org/officeDocument/2006/relationships/theme" Target="theme/theme1.xml"/><Relationship Id="rId54" Type="http://schemas.openxmlformats.org/officeDocument/2006/relationships/slide" Target="slides/slide53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91" Type="http://schemas.openxmlformats.org/officeDocument/2006/relationships/slide" Target="slides/slide90.xml"/><Relationship Id="rId96" Type="http://schemas.openxmlformats.org/officeDocument/2006/relationships/slide" Target="slides/slide95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49" Type="http://schemas.openxmlformats.org/officeDocument/2006/relationships/slide" Target="slides/slide48.xml"/><Relationship Id="rId114" Type="http://schemas.openxmlformats.org/officeDocument/2006/relationships/slide" Target="slides/slide113.xml"/><Relationship Id="rId119" Type="http://schemas.openxmlformats.org/officeDocument/2006/relationships/slide" Target="slides/slide118.xml"/><Relationship Id="rId44" Type="http://schemas.openxmlformats.org/officeDocument/2006/relationships/slide" Target="slides/slide43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81" Type="http://schemas.openxmlformats.org/officeDocument/2006/relationships/slide" Target="slides/slide80.xml"/><Relationship Id="rId86" Type="http://schemas.openxmlformats.org/officeDocument/2006/relationships/slide" Target="slides/slide85.xml"/><Relationship Id="rId130" Type="http://schemas.openxmlformats.org/officeDocument/2006/relationships/tableStyles" Target="tableStyles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109" Type="http://schemas.openxmlformats.org/officeDocument/2006/relationships/slide" Target="slides/slide10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97" Type="http://schemas.openxmlformats.org/officeDocument/2006/relationships/slide" Target="slides/slide96.xml"/><Relationship Id="rId104" Type="http://schemas.openxmlformats.org/officeDocument/2006/relationships/slide" Target="slides/slide103.xml"/><Relationship Id="rId120" Type="http://schemas.openxmlformats.org/officeDocument/2006/relationships/slide" Target="slides/slide119.xml"/><Relationship Id="rId125" Type="http://schemas.openxmlformats.org/officeDocument/2006/relationships/slide" Target="slides/slide124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slide" Target="slides/slide86.xml"/><Relationship Id="rId110" Type="http://schemas.openxmlformats.org/officeDocument/2006/relationships/slide" Target="slides/slide109.xml"/><Relationship Id="rId115" Type="http://schemas.openxmlformats.org/officeDocument/2006/relationships/slide" Target="slides/slide114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56" Type="http://schemas.openxmlformats.org/officeDocument/2006/relationships/slide" Target="slides/slide55.xml"/><Relationship Id="rId77" Type="http://schemas.openxmlformats.org/officeDocument/2006/relationships/slide" Target="slides/slide76.xml"/><Relationship Id="rId100" Type="http://schemas.openxmlformats.org/officeDocument/2006/relationships/slide" Target="slides/slide99.xml"/><Relationship Id="rId105" Type="http://schemas.openxmlformats.org/officeDocument/2006/relationships/slide" Target="slides/slide104.xml"/><Relationship Id="rId126" Type="http://schemas.openxmlformats.org/officeDocument/2006/relationships/slide" Target="slides/slide12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93" Type="http://schemas.openxmlformats.org/officeDocument/2006/relationships/slide" Target="slides/slide92.xml"/><Relationship Id="rId98" Type="http://schemas.openxmlformats.org/officeDocument/2006/relationships/slide" Target="slides/slide97.xml"/><Relationship Id="rId121" Type="http://schemas.openxmlformats.org/officeDocument/2006/relationships/slide" Target="slides/slide120.xml"/><Relationship Id="rId3" Type="http://schemas.openxmlformats.org/officeDocument/2006/relationships/slide" Target="slides/slide2.xml"/><Relationship Id="rId25" Type="http://schemas.openxmlformats.org/officeDocument/2006/relationships/slide" Target="slides/slide24.xml"/><Relationship Id="rId46" Type="http://schemas.openxmlformats.org/officeDocument/2006/relationships/slide" Target="slides/slide45.xml"/><Relationship Id="rId67" Type="http://schemas.openxmlformats.org/officeDocument/2006/relationships/slide" Target="slides/slide66.xml"/><Relationship Id="rId116" Type="http://schemas.openxmlformats.org/officeDocument/2006/relationships/slide" Target="slides/slide11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62" Type="http://schemas.openxmlformats.org/officeDocument/2006/relationships/slide" Target="slides/slide61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111" Type="http://schemas.openxmlformats.org/officeDocument/2006/relationships/slide" Target="slides/slide110.xml"/><Relationship Id="rId15" Type="http://schemas.openxmlformats.org/officeDocument/2006/relationships/slide" Target="slides/slide14.xml"/><Relationship Id="rId36" Type="http://schemas.openxmlformats.org/officeDocument/2006/relationships/slide" Target="slides/slide35.xml"/><Relationship Id="rId57" Type="http://schemas.openxmlformats.org/officeDocument/2006/relationships/slide" Target="slides/slide56.xml"/><Relationship Id="rId106" Type="http://schemas.openxmlformats.org/officeDocument/2006/relationships/slide" Target="slides/slide105.xml"/><Relationship Id="rId127" Type="http://schemas.openxmlformats.org/officeDocument/2006/relationships/presProps" Target="presProps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52" Type="http://schemas.openxmlformats.org/officeDocument/2006/relationships/slide" Target="slides/slide51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94" Type="http://schemas.openxmlformats.org/officeDocument/2006/relationships/slide" Target="slides/slide93.xml"/><Relationship Id="rId99" Type="http://schemas.openxmlformats.org/officeDocument/2006/relationships/slide" Target="slides/slide98.xml"/><Relationship Id="rId101" Type="http://schemas.openxmlformats.org/officeDocument/2006/relationships/slide" Target="slides/slide100.xml"/><Relationship Id="rId122" Type="http://schemas.openxmlformats.org/officeDocument/2006/relationships/slide" Target="slides/slide12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26" Type="http://schemas.openxmlformats.org/officeDocument/2006/relationships/slide" Target="slides/slide2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F92B2-8E14-5324-C82E-1E6A841485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14E876-9889-8A29-E34F-4264C87218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C3321B-5676-78FF-F284-DFC7BA99A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8316AA-F777-6BB9-C7B9-EC3322F7D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694203-24C0-90AC-2481-5525EEFE1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613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8FAA2-5A9A-55CC-086F-35D084115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E3CEC4-77FD-C079-9D2C-1CC015228A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5C502-EEF4-0038-8763-1450E3D7D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AC1162-F20D-5A5C-4652-CD615599E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6EF6CE-29ED-B9ED-DE49-A2C425DCB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265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B9999B-0F3A-E8D3-C14C-AC0885479B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261B04-959E-8FE4-EC78-130676412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AF871-FF07-FA36-47D3-E7BCFA7BE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BE96FB-63BF-5960-9A28-B9855EB3D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94DAC4-82AB-9D2A-E780-3EC8F8671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26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01B85-FD14-CCBE-4B5C-E5F4DCC00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F7BE8A-1F1C-E43E-0090-17A7F5F769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EEE077-5112-4979-FB4A-C9511CEB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FC14B-C88C-410A-59F9-0CBE84BD1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EE56A2-5CCB-1B69-5940-9983177BD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936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04C9E-CC4F-C153-41E0-9809635EB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613C95-81E1-C205-DFFB-D57710A98F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F7017-0AC6-AA11-ADE0-26DDD6E4B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33FBB2-0F34-2987-B438-FF5469A95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CC013-6895-C8F1-D887-653D74A2F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812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97723-97AA-ED07-9E01-ADB2FA154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6FB232-2034-65BC-3A84-CE060BF201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735836-0294-A294-D324-E115F8CCBE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44A233-66D9-1C08-37D9-FC09FCE4F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910D1C-8476-9CD5-235B-992FE4CA5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A1AE7F-1485-B804-C164-57A2B13C2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585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8F8CC-53D7-EDA4-DCED-B0E51430A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A5A5B5-5B2B-C292-4960-CCC5C0AFD6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DD183D-90F7-BBFF-C716-122ABFDBB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1FED59-4FF9-CCCD-1034-46FF9E0CEF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FA0843-1CC2-0E27-F7B8-EB121C4820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0A3008-B829-CB96-FAC8-52FB453E0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DF2BEE-7667-B698-F0DC-FA7D19C80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7D0757-F09F-F012-80C5-568A26D6C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994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636C2-4795-09E1-DDE9-7F2345A28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088278-BAC5-3EF4-C0E5-DA4E936EF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852148-40FA-A039-30F1-7E6492854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2CAC2A-271D-0746-A791-F2B93A084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07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685C74-8DB0-BFC8-D8E4-43848B1DD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3D4BEE-745C-D635-6B04-513FEAA83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53A58B-4C14-9027-DAC4-2D0B4BDFA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873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01F4C-8FE2-DE5B-71BA-8F983CCE3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4D0354-A505-0F57-F96F-1D66444140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F0E118-B199-81B1-8918-99600E4AA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45E0FA-9742-26D8-B560-C99AAC31C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0E142C-C730-3079-A4B3-2BBDA0811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37D01-6F45-EA9A-EFA5-63E20C2F6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547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A6A5E-58E4-B995-4EFA-9D54AD71C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405F93-0E97-7F82-761F-4BF87BC03F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ED9F19-CB50-37D4-0DC2-D5D097232D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541DAE-6C19-C34B-73B4-149FFC0DB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1F43F4-4EE2-1D15-E41E-3F89259BD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566E38-B1FB-4548-7E32-524FF0211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039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9C1BF1-573A-654E-FC2F-65643E10F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7AC074-6D27-2D32-B796-A70300009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682BFD-AAA5-CFF2-1486-C4B9C5C8F0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AD765-E1DE-2D4F-8D54-40CF4558C178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266B32-ABA7-F6D3-08A5-F50D0C3D82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5971E4-37C4-EAF7-166E-16C29DD6BB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70D57-B8E3-9948-8958-800952EED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652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png"/><Relationship Id="rId1" Type="http://schemas.openxmlformats.org/officeDocument/2006/relationships/slideLayout" Target="../slideLayouts/slideLayout2.xml"/></Relationships>
</file>

<file path=ppt/slides/_rels/slide1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2.xml"/></Relationships>
</file>

<file path=ppt/slides/_rels/slide1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2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2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8.png"/><Relationship Id="rId1" Type="http://schemas.openxmlformats.org/officeDocument/2006/relationships/slideLayout" Target="../slideLayouts/slideLayout2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png"/><Relationship Id="rId1" Type="http://schemas.openxmlformats.org/officeDocument/2006/relationships/slideLayout" Target="../slideLayouts/slideLayout2.xml"/></Relationships>
</file>

<file path=ppt/slides/_rels/slide1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2.xml"/></Relationships>
</file>

<file path=ppt/slides/_rels/slide10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2.png"/><Relationship Id="rId1" Type="http://schemas.openxmlformats.org/officeDocument/2006/relationships/slideLayout" Target="../slideLayouts/slideLayout2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2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4.png"/><Relationship Id="rId1" Type="http://schemas.openxmlformats.org/officeDocument/2006/relationships/slideLayout" Target="../slideLayouts/slideLayout2.xml"/></Relationships>
</file>

<file path=ppt/slides/_rels/slide1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5.png"/><Relationship Id="rId1" Type="http://schemas.openxmlformats.org/officeDocument/2006/relationships/slideLayout" Target="../slideLayouts/slideLayout2.xml"/></Relationships>
</file>

<file path=ppt/slides/_rels/slide1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6.png"/><Relationship Id="rId1" Type="http://schemas.openxmlformats.org/officeDocument/2006/relationships/slideLayout" Target="../slideLayouts/slideLayout2.xml"/></Relationships>
</file>

<file path=ppt/slides/_rels/slide1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7.png"/><Relationship Id="rId1" Type="http://schemas.openxmlformats.org/officeDocument/2006/relationships/slideLayout" Target="../slideLayouts/slideLayout2.xml"/></Relationships>
</file>

<file path=ppt/slides/_rels/slide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2.xml"/></Relationships>
</file>

<file path=ppt/slides/_rels/slide1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png"/><Relationship Id="rId1" Type="http://schemas.openxmlformats.org/officeDocument/2006/relationships/slideLayout" Target="../slideLayouts/slideLayout2.xml"/></Relationships>
</file>

<file path=ppt/slides/_rels/slide1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2.xml"/></Relationships>
</file>

<file path=ppt/slides/_rels/slide1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2.xml"/></Relationships>
</file>

<file path=ppt/slides/_rels/slide1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3.png"/><Relationship Id="rId1" Type="http://schemas.openxmlformats.org/officeDocument/2006/relationships/slideLayout" Target="../slideLayouts/slideLayout2.xml"/></Relationships>
</file>

<file path=ppt/slides/_rels/slide1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2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2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2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2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2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2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2.xml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2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emf"/><Relationship Id="rId1" Type="http://schemas.openxmlformats.org/officeDocument/2006/relationships/slideLayout" Target="../slideLayouts/slideLayout2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2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2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emf"/><Relationship Id="rId1" Type="http://schemas.openxmlformats.org/officeDocument/2006/relationships/slideLayout" Target="../slideLayouts/slideLayout2.xml"/></Relationships>
</file>

<file path=ppt/slides/_rels/slide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emf"/><Relationship Id="rId1" Type="http://schemas.openxmlformats.org/officeDocument/2006/relationships/slideLayout" Target="../slideLayouts/slideLayout2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emf"/><Relationship Id="rId1" Type="http://schemas.openxmlformats.org/officeDocument/2006/relationships/slideLayout" Target="../slideLayouts/slideLayout2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emf"/><Relationship Id="rId1" Type="http://schemas.openxmlformats.org/officeDocument/2006/relationships/slideLayout" Target="../slideLayouts/slideLayout2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emf"/><Relationship Id="rId1" Type="http://schemas.openxmlformats.org/officeDocument/2006/relationships/slideLayout" Target="../slideLayouts/slideLayout2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emf"/><Relationship Id="rId1" Type="http://schemas.openxmlformats.org/officeDocument/2006/relationships/slideLayout" Target="../slideLayouts/slideLayout2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2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emf"/><Relationship Id="rId1" Type="http://schemas.openxmlformats.org/officeDocument/2006/relationships/slideLayout" Target="../slideLayouts/slideLayout2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1.emf"/><Relationship Id="rId1" Type="http://schemas.openxmlformats.org/officeDocument/2006/relationships/slideLayout" Target="../slideLayouts/slideLayout2.xml"/></Relationships>
</file>

<file path=ppt/slides/_rels/slide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emf"/><Relationship Id="rId1" Type="http://schemas.openxmlformats.org/officeDocument/2006/relationships/slideLayout" Target="../slideLayouts/slideLayout2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7527E-C7B6-F675-F7A6-F8BD94EF90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25286" y="2766218"/>
            <a:ext cx="10515600" cy="1325563"/>
          </a:xfrm>
        </p:spPr>
        <p:txBody>
          <a:bodyPr>
            <a:normAutofit fontScale="90000"/>
          </a:bodyPr>
          <a:lstStyle/>
          <a:p>
            <a:pPr marL="0" marR="0" algn="ctr">
              <a:spcBef>
                <a:spcPts val="600"/>
              </a:spcBef>
              <a:spcAft>
                <a:spcPts val="0"/>
              </a:spcAft>
            </a:pPr>
            <a:r>
              <a:rPr lang="en-US" sz="5300" b="1" u="none" strike="noStrike" kern="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INFORMATION FILES</a:t>
            </a:r>
            <a:br>
              <a:rPr lang="en-US" sz="1800" b="1" u="none" strike="noStrike" kern="0" dirty="0">
                <a:effectLst/>
                <a:latin typeface="Arno Pro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sz="1800" b="1" u="none" strike="noStrike" kern="0" dirty="0">
                <a:effectLst/>
                <a:latin typeface="Arno Pro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sz="1800" b="1" u="none" strike="noStrike" kern="0" dirty="0">
                <a:effectLst/>
                <a:latin typeface="Arno Pro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200" b="1" u="none" strike="noStrike" kern="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Development of Microflow Ultra High Performance Liquid</a:t>
            </a:r>
            <a:r>
              <a:rPr lang="en-US" sz="2200" b="1" u="sng" strike="noStrike" kern="0" dirty="0"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b="1" u="none" strike="noStrike" kern="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Chromatography -Mass Spectrometry Metabolomic Assays</a:t>
            </a:r>
            <a:r>
              <a:rPr lang="en-US" sz="2200" b="1" u="sng" strike="noStrike" kern="0" dirty="0"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b="1" u="none" strike="noStrike" kern="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for Analysis of Mammalian Biofluids</a:t>
            </a:r>
            <a:br>
              <a:rPr lang="en-US" sz="2200" b="1" u="sng" kern="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nnie J. Harwood-Stamper</a:t>
            </a:r>
            <a:r>
              <a:rPr lang="en-US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, Caroline A. Rowland</a:t>
            </a:r>
            <a:r>
              <a:rPr lang="en-US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, and Warwick B. Dunn</a:t>
            </a:r>
            <a:r>
              <a:rPr lang="en-US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School of Biosciences, University of Birmingham, Edgbaston, Birmingham, B15 2TT, UK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Defence Science and Technology Laboratory, </a:t>
            </a:r>
            <a:r>
              <a:rPr lang="en-GB" sz="2200" dirty="0" err="1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Porton</a:t>
            </a:r>
            <a:r>
              <a:rPr lang="en-GB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Down, Salisbury, SP4 0JQ, UK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2200" baseline="300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Centre for Metabolomics Research, Department of Biochemistry, Cell and Systems Biology, Institute of Systems, Molecular and Integrative Biology, University of Liverpool, Biosciences Building, Crown Street, Liverpool, L69 7ZB, UK</a:t>
            </a:r>
            <a:br>
              <a:rPr lang="en-US" sz="2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0028388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3 – Compound Discoverer v3.1 workflow and parameters applied to </a:t>
            </a:r>
            <a:r>
              <a:rPr lang="en-US" b="1" dirty="0" err="1"/>
              <a:t>analyse</a:t>
            </a:r>
            <a:r>
              <a:rPr lang="en-US" b="1" dirty="0"/>
              <a:t> data acquired </a:t>
            </a:r>
            <a:br>
              <a:rPr lang="en-US" b="1" dirty="0"/>
            </a:br>
            <a:r>
              <a:rPr lang="en-US" b="1" dirty="0"/>
              <a:t>for porcine samples</a:t>
            </a:r>
          </a:p>
        </p:txBody>
      </p:sp>
    </p:spTree>
    <p:extLst>
      <p:ext uri="{BB962C8B-B14F-4D97-AF65-F5344CB8AC3E}">
        <p14:creationId xmlns:p14="http://schemas.microsoft.com/office/powerpoint/2010/main" val="3197619848"/>
      </p:ext>
    </p:extLst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85876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2 – Distribution of peak width (FWHM, minutes) for each sample dilution, assay, sample type </a:t>
            </a:r>
            <a:br>
              <a:rPr lang="en-US" b="1" dirty="0"/>
            </a:br>
            <a:r>
              <a:rPr lang="en-US" b="1" dirty="0"/>
              <a:t>and UHPLC column </a:t>
            </a:r>
            <a:r>
              <a:rPr lang="en-US" b="1" dirty="0" err="1"/>
              <a:t>i.d.</a:t>
            </a:r>
            <a:br>
              <a:rPr lang="en-US" b="1" dirty="0"/>
            </a:br>
            <a:br>
              <a:rPr lang="en-US" b="1" dirty="0"/>
            </a:br>
            <a:r>
              <a:rPr lang="en-US" sz="3600" dirty="0"/>
              <a:t>Compounds were filtered so that only peaks with a RSD &lt; 30% for QC samples remained.</a:t>
            </a:r>
            <a:br>
              <a:rPr lang="en-US" sz="3600" dirty="0"/>
            </a:br>
            <a:br>
              <a:rPr lang="en-US" sz="3600" dirty="0"/>
            </a:br>
            <a:r>
              <a:rPr lang="en-US" sz="3600" dirty="0"/>
              <a:t>*** p &lt; 0.001</a:t>
            </a:r>
            <a:br>
              <a:rPr lang="en-US" sz="3600" dirty="0"/>
            </a:br>
            <a:r>
              <a:rPr lang="en-US" sz="3600" dirty="0"/>
              <a:t>** p&lt; 0.01</a:t>
            </a:r>
            <a:br>
              <a:rPr lang="en-US" sz="3600" dirty="0"/>
            </a:br>
            <a:r>
              <a:rPr lang="en-US" sz="3600" dirty="0"/>
              <a:t>* p&lt; 0.05</a:t>
            </a:r>
            <a:br>
              <a:rPr lang="en-US" dirty="0"/>
            </a:br>
            <a:br>
              <a:rPr lang="en-US" b="1" dirty="0"/>
            </a:b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1435423"/>
      </p:ext>
    </p:extLst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5879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89DB8D4-7A98-8739-8544-9465C012A6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1440" y="1334729"/>
            <a:ext cx="6929120" cy="536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927408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09093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777A06-A715-061E-603D-6594A81518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0960" y="1404747"/>
            <a:ext cx="6990080" cy="5344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175408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566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F5A1F5B-1A15-7DBC-E7F5-47E21E2039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2560" y="1470336"/>
            <a:ext cx="6786880" cy="527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9937351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9138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D37DEF3-44DB-4885-A319-8F8DF2CD0C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1760" y="1456722"/>
            <a:ext cx="6888480" cy="5151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8037656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1823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6CDC74A-7EA6-234D-C518-14E20CD4B6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2240" y="1440711"/>
            <a:ext cx="6827520" cy="5212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3955373"/>
      </p:ext>
    </p:extLst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902AB6-D546-4B01-197D-A73659BECB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9840" y="1473200"/>
            <a:ext cx="7132320" cy="538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7379398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872" y="90805"/>
            <a:ext cx="11969496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A96524E-F254-9555-32C7-5BD1A20768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0960" y="1306635"/>
            <a:ext cx="6990080" cy="544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4181151"/>
      </p:ext>
    </p:extLst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3736" y="127381"/>
            <a:ext cx="118872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543C924-794B-5DF2-88CD-ADA107E1E5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1920" y="1330960"/>
            <a:ext cx="6868160" cy="5527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90861"/>
      </p:ext>
    </p:extLst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429000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3 – Distribution of chromatographic peak areas for each sample dilution, assay, sample type </a:t>
            </a:r>
            <a:br>
              <a:rPr lang="en-US" b="1" dirty="0"/>
            </a:br>
            <a:r>
              <a:rPr lang="en-US" b="1" dirty="0"/>
              <a:t>and UHPLC column </a:t>
            </a:r>
            <a:r>
              <a:rPr lang="en-US" b="1" dirty="0" err="1"/>
              <a:t>i.d.</a:t>
            </a:r>
            <a:br>
              <a:rPr lang="en-US" dirty="0"/>
            </a:br>
            <a:br>
              <a:rPr lang="en-US" dirty="0"/>
            </a:br>
            <a:r>
              <a:rPr lang="en-US" sz="3600" dirty="0"/>
              <a:t>Compounds were filtered so that only peaks with a RSD &lt; 30% for QC samples remained.</a:t>
            </a:r>
            <a:br>
              <a:rPr lang="en-US" sz="4400" dirty="0"/>
            </a:br>
            <a:br>
              <a:rPr lang="en-US" dirty="0"/>
            </a:br>
            <a:r>
              <a:rPr lang="en-US" sz="3600" dirty="0"/>
              <a:t>*** p &lt; 0.001</a:t>
            </a:r>
            <a:br>
              <a:rPr lang="en-US" sz="3600" dirty="0"/>
            </a:br>
            <a:r>
              <a:rPr lang="en-US" sz="3600" dirty="0"/>
              <a:t>** p &lt; 0.01</a:t>
            </a:r>
            <a:br>
              <a:rPr lang="en-US" sz="3600" dirty="0"/>
            </a:br>
            <a:r>
              <a:rPr lang="en-US" sz="3600" dirty="0"/>
              <a:t>* p &lt; 0.05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27400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A01A07D-CEDB-0CA8-C9AA-AD76A687F4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950" y="669925"/>
            <a:ext cx="9944100" cy="5518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761430"/>
      </p:ext>
    </p:extLst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994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B82A78B-21B7-9E7A-277E-3EDDEB39D7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495529"/>
            <a:ext cx="7772400" cy="4525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566621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03692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CC08AE8-E8A7-BB76-3B00-218935887D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603308"/>
            <a:ext cx="7772400" cy="515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804707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9A2B2C9-3D9C-1699-8C31-436921A9DF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368954"/>
            <a:ext cx="7772400" cy="5489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787143"/>
      </p:ext>
    </p:extLst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566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75F2BC0-A58F-5C9B-7739-EBECBFC8D0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313725"/>
            <a:ext cx="7772400" cy="54009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4509711"/>
      </p:ext>
    </p:extLst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0597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46251AD-4143-B11B-AFEA-94E49FB759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386139"/>
            <a:ext cx="7772400" cy="5365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016644"/>
      </p:ext>
    </p:extLst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717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60E45AC-6AF9-2720-CE8B-5136A68ABC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5792" y="1462742"/>
            <a:ext cx="7772400" cy="5322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8797560"/>
      </p:ext>
    </p:extLst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3256" y="109093"/>
            <a:ext cx="11905488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32A644F-2A46-00FA-29A0-AF868C378F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384153"/>
            <a:ext cx="7772400" cy="5364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2456041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536" y="-210947"/>
            <a:ext cx="11996928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B1DB0A2-FFDA-33E1-EBB2-5556D60D25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838669"/>
            <a:ext cx="7772400" cy="6168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8744318"/>
      </p:ext>
    </p:extLst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429000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4 – Distribution of chromatographic peak areas for the 1 in 16 dilution of each assay type for both the 2.1mm id (blue) and 1.0mm id (red)</a:t>
            </a:r>
            <a:br>
              <a:rPr lang="en-US" dirty="0"/>
            </a:br>
            <a:br>
              <a:rPr lang="en-US" dirty="0"/>
            </a:br>
            <a:r>
              <a:rPr lang="en-US" sz="3600" dirty="0"/>
              <a:t>Compounds were filtered so that only peaks with a RSD &lt; 30% for QC samples remained.</a:t>
            </a:r>
            <a:br>
              <a:rPr lang="en-US" sz="4900" dirty="0"/>
            </a:br>
            <a:br>
              <a:rPr lang="en-US" sz="3600" dirty="0"/>
            </a:br>
            <a:r>
              <a:rPr lang="en-US" sz="3600" dirty="0"/>
              <a:t>*** p &lt; 0.001</a:t>
            </a:r>
            <a:br>
              <a:rPr lang="en-US" sz="3600" dirty="0"/>
            </a:br>
            <a:r>
              <a:rPr lang="en-US" sz="3600" dirty="0"/>
              <a:t>** p &lt; 0.01</a:t>
            </a:r>
            <a:br>
              <a:rPr lang="en-US" sz="3600" dirty="0"/>
            </a:br>
            <a:r>
              <a:rPr lang="en-US" sz="3600" dirty="0"/>
              <a:t>* p &lt; 0.05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3136770"/>
      </p:ext>
    </p:extLst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79508D4-C359-46DB-751A-C778A0D4FC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258840"/>
            <a:ext cx="7772400" cy="6340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10012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55F5129-1892-68F6-CE85-7A3040409C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972" y="474345"/>
            <a:ext cx="11616055" cy="5909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6547427"/>
      </p:ext>
    </p:extLst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5 – Overlap of annotated metabolites for porcine plasma (red) and porcine tear fluid (blue)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9438345"/>
      </p:ext>
    </p:extLst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45468-DDB4-9CFA-C7D6-B7F0C4FE0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ipids negative ion mod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70D38E7-B4CB-23BB-0DFA-665C1B3F65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4250" y="1621536"/>
            <a:ext cx="7683500" cy="495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8428590"/>
      </p:ext>
    </p:extLst>
  </p:cSld>
  <p:clrMapOvr>
    <a:masterClrMapping/>
  </p:clrMapOvr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45468-DDB4-9CFA-C7D6-B7F0C4FE0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ipids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A3CF485-7DC6-DC06-8464-52E9B66D0E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5375" y="1690688"/>
            <a:ext cx="7461250" cy="473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3485624"/>
      </p:ext>
    </p:extLst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6 – Overlap of annotated metabolites for porcine urine (red) and porcine tear fluid (blue)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1547480"/>
      </p:ext>
    </p:extLst>
  </p:cSld>
  <p:clrMapOvr>
    <a:masterClrMapping/>
  </p:clrMapOvr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45468-DDB4-9CFA-C7D6-B7F0C4FE0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Reversed phase aqueous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63CCB5A-817C-F985-FBD3-D5001AD054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8562" y="1778000"/>
            <a:ext cx="7254875" cy="5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9760400"/>
      </p:ext>
    </p:extLst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45468-DDB4-9CFA-C7D6-B7F0C4FE0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Reversed phase aqueous positive ion mod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EAE74F4-9860-17BD-58C1-623242333B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4250" y="1690688"/>
            <a:ext cx="7683500" cy="4984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57232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52EE19A-B17B-5393-80CB-3BA6839281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435" y="215900"/>
            <a:ext cx="11581130" cy="642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296790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91A3627-9051-BF9E-449B-A1765888EB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375" y="359092"/>
            <a:ext cx="11525250" cy="61398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472052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939080-6A94-C41C-C2C8-C3CF41BA00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090" y="1207770"/>
            <a:ext cx="11259820" cy="4442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1737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3308D08-A0B2-A5D9-53A2-C8760D7C95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563" y="219456"/>
            <a:ext cx="761887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87002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4 – Base Peak Ion Chromatograms for each assay, sample type and UHPLC column </a:t>
            </a:r>
            <a:r>
              <a:rPr lang="en-US" b="1" dirty="0" err="1"/>
              <a:t>i.d.</a:t>
            </a:r>
            <a:r>
              <a:rPr lang="en-US" b="1" dirty="0"/>
              <a:t> for 1 in 4 dilution data</a:t>
            </a:r>
          </a:p>
        </p:txBody>
      </p:sp>
    </p:spTree>
    <p:extLst>
      <p:ext uri="{BB962C8B-B14F-4D97-AF65-F5344CB8AC3E}">
        <p14:creationId xmlns:p14="http://schemas.microsoft.com/office/powerpoint/2010/main" val="209543485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3" y="127131"/>
            <a:ext cx="11625943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08BBC3-697E-4122-038B-354769DF0E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750" y="1643211"/>
            <a:ext cx="8572500" cy="4584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258007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7457" y="127131"/>
            <a:ext cx="11527972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C5A547B-3ABD-503D-4F92-85945BBF98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2600" y="1772558"/>
            <a:ext cx="8686800" cy="4254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5806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C0100-6658-0117-BAEA-12129E1853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US" b="1" dirty="0"/>
              <a:t>S1 – Serial dilution calculations </a:t>
            </a:r>
            <a:br>
              <a:rPr lang="en-US" b="1" dirty="0"/>
            </a:br>
            <a:r>
              <a:rPr lang="en-US" b="1" dirty="0"/>
              <a:t>and volumes applied</a:t>
            </a:r>
          </a:p>
        </p:txBody>
      </p:sp>
    </p:spTree>
    <p:extLst>
      <p:ext uri="{BB962C8B-B14F-4D97-AF65-F5344CB8AC3E}">
        <p14:creationId xmlns:p14="http://schemas.microsoft.com/office/powerpoint/2010/main" val="197697679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2143" y="127131"/>
            <a:ext cx="11571514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AF19579-AC16-8CDB-B797-7C08DD061D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1650" y="1603220"/>
            <a:ext cx="86487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777539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4" y="127131"/>
            <a:ext cx="11604172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0743B82-81BE-FB33-A81C-F71BDEEDBA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9100" y="1663747"/>
            <a:ext cx="8813800" cy="435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52911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3" y="127131"/>
            <a:ext cx="11625943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F193696-1343-BAFF-9D75-75611C67F8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1587272"/>
            <a:ext cx="8534400" cy="454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569770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7457" y="127131"/>
            <a:ext cx="11527972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D546A8E-22CE-3651-3DC4-070D63437B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400" y="1618081"/>
            <a:ext cx="85852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95102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2143" y="127131"/>
            <a:ext cx="11571514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D428C00-7B30-1D36-5039-256E89598E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1150" y="1523936"/>
            <a:ext cx="9029700" cy="4851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296057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4" y="127131"/>
            <a:ext cx="11604172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2053699-B7AB-90EC-1C0B-4FA1A77999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550" y="1594582"/>
            <a:ext cx="8724900" cy="4508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410672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C7DD173-3868-C5A0-F9FE-BBA8E653D4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2100" y="1653862"/>
            <a:ext cx="9067800" cy="477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010675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2EC44A3-A627-FC24-4E1C-29020AE992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4650" y="1658234"/>
            <a:ext cx="8902700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46086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3212FD8-F140-AD56-B8FC-EF4774A2FA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8950" y="1594604"/>
            <a:ext cx="8674100" cy="468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637717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85D4111-5A67-08C9-EE2F-303588B36D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1000" y="1600852"/>
            <a:ext cx="8890000" cy="449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200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61963F0-9D22-F321-A65B-467BAEC8BF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8525" y="633603"/>
            <a:ext cx="10254949" cy="6224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593752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4EC5CA9-5303-FB82-463C-725CA1AF3A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1548274"/>
            <a:ext cx="85344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911744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3BA0D78-C2B0-27C2-2E35-B8BF22E928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1800" y="1646964"/>
            <a:ext cx="8788400" cy="438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50183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2E0768-7275-913F-78ED-90E9AD5157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1800" y="1615502"/>
            <a:ext cx="8788400" cy="459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660551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3177155-673C-32A4-1E34-5D79755564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8950" y="1656790"/>
            <a:ext cx="8674100" cy="434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587891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5 – PCA scores and loading plots applied to assess data variability and differences related to sample dilution for each assay, sample type and UHPLC column </a:t>
            </a:r>
            <a:r>
              <a:rPr lang="en-US" b="1" dirty="0" err="1"/>
              <a:t>i.d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22925143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3" y="127131"/>
            <a:ext cx="11625943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9218" name="Picture 2">
            <a:extLst>
              <a:ext uri="{FF2B5EF4-FFF2-40B4-BE49-F238E27FC236}">
                <a16:creationId xmlns:a16="http://schemas.microsoft.com/office/drawing/2014/main" id="{F2F7FFCE-61AC-01D3-5B30-76E60C1F4D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018" y="1188720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>
            <a:extLst>
              <a:ext uri="{FF2B5EF4-FFF2-40B4-BE49-F238E27FC236}">
                <a16:creationId xmlns:a16="http://schemas.microsoft.com/office/drawing/2014/main" id="{9FBC394D-854F-FB93-0EFB-073CEEDBB1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2760" y="1325880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9196489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7457" y="127131"/>
            <a:ext cx="11527972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0242" name="Picture 2">
            <a:extLst>
              <a:ext uri="{FF2B5EF4-FFF2-40B4-BE49-F238E27FC236}">
                <a16:creationId xmlns:a16="http://schemas.microsoft.com/office/drawing/2014/main" id="{E50E9027-03AC-8177-9720-F7644C6811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450" y="1169126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4" name="Picture 4">
            <a:extLst>
              <a:ext uri="{FF2B5EF4-FFF2-40B4-BE49-F238E27FC236}">
                <a16:creationId xmlns:a16="http://schemas.microsoft.com/office/drawing/2014/main" id="{3C4370C8-2017-1226-28C7-FBBAE12B7F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4650" y="1306286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9787824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2143" y="127131"/>
            <a:ext cx="11571514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1266" name="Picture 2">
            <a:extLst>
              <a:ext uri="{FF2B5EF4-FFF2-40B4-BE49-F238E27FC236}">
                <a16:creationId xmlns:a16="http://schemas.microsoft.com/office/drawing/2014/main" id="{635836E3-394F-FCB2-2E37-831FAB1287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943" y="1213213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68" name="Picture 4">
            <a:extLst>
              <a:ext uri="{FF2B5EF4-FFF2-40B4-BE49-F238E27FC236}">
                <a16:creationId xmlns:a16="http://schemas.microsoft.com/office/drawing/2014/main" id="{8C3E9E1F-C968-EBE0-1BF7-E0CDC0578E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0617" y="1350373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3187381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3914" y="127131"/>
            <a:ext cx="11604172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2290" name="Picture 2">
            <a:extLst>
              <a:ext uri="{FF2B5EF4-FFF2-40B4-BE49-F238E27FC236}">
                <a16:creationId xmlns:a16="http://schemas.microsoft.com/office/drawing/2014/main" id="{B2FA8153-19E1-4A53-D00D-E99F30B98A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914" y="1244469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92" name="Picture 4">
            <a:extLst>
              <a:ext uri="{FF2B5EF4-FFF2-40B4-BE49-F238E27FC236}">
                <a16:creationId xmlns:a16="http://schemas.microsoft.com/office/drawing/2014/main" id="{97F19E05-1285-05B5-46DD-C6333CDF00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0212" y="1381629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12834278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008" y="127131"/>
            <a:ext cx="12060935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3314" name="Picture 2">
            <a:extLst>
              <a:ext uri="{FF2B5EF4-FFF2-40B4-BE49-F238E27FC236}">
                <a16:creationId xmlns:a16="http://schemas.microsoft.com/office/drawing/2014/main" id="{BE893DE3-24B8-8478-1D7F-636591B0F4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144" y="1355924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16" name="Picture 4">
            <a:extLst>
              <a:ext uri="{FF2B5EF4-FFF2-40B4-BE49-F238E27FC236}">
                <a16:creationId xmlns:a16="http://schemas.microsoft.com/office/drawing/2014/main" id="{4352C6D2-16E2-B486-46A9-208C487D33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2385" y="1493084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06411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2 – Compound Discoverer v3.0 workflow and parameters applied to </a:t>
            </a:r>
            <a:r>
              <a:rPr lang="en-US" b="1" dirty="0" err="1"/>
              <a:t>analyse</a:t>
            </a:r>
            <a:r>
              <a:rPr lang="en-US" b="1" dirty="0"/>
              <a:t> data acquired </a:t>
            </a:r>
            <a:br>
              <a:rPr lang="en-US" b="1" dirty="0"/>
            </a:br>
            <a:r>
              <a:rPr lang="en-US" b="1" dirty="0"/>
              <a:t>for human samples</a:t>
            </a:r>
          </a:p>
        </p:txBody>
      </p:sp>
    </p:spTree>
    <p:extLst>
      <p:ext uri="{BB962C8B-B14F-4D97-AF65-F5344CB8AC3E}">
        <p14:creationId xmlns:p14="http://schemas.microsoft.com/office/powerpoint/2010/main" val="79825268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152" y="127131"/>
            <a:ext cx="12051792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4338" name="Picture 2">
            <a:extLst>
              <a:ext uri="{FF2B5EF4-FFF2-40B4-BE49-F238E27FC236}">
                <a16:creationId xmlns:a16="http://schemas.microsoft.com/office/drawing/2014/main" id="{AAA23F4D-FD68-900B-E0C2-91EEF91A0A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457" y="1159329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340" name="Picture 4">
            <a:extLst>
              <a:ext uri="{FF2B5EF4-FFF2-40B4-BE49-F238E27FC236}">
                <a16:creationId xmlns:a16="http://schemas.microsoft.com/office/drawing/2014/main" id="{56560508-7495-4CB2-1635-9EB5E7AFF8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3587" y="1296489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6178278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440" y="127131"/>
            <a:ext cx="1197864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5364" name="Picture 4">
            <a:extLst>
              <a:ext uri="{FF2B5EF4-FFF2-40B4-BE49-F238E27FC236}">
                <a16:creationId xmlns:a16="http://schemas.microsoft.com/office/drawing/2014/main" id="{709E8FBB-D574-C86C-DEFC-194F4B52F3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143" y="1172392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366" name="Picture 6">
            <a:extLst>
              <a:ext uri="{FF2B5EF4-FFF2-40B4-BE49-F238E27FC236}">
                <a16:creationId xmlns:a16="http://schemas.microsoft.com/office/drawing/2014/main" id="{B5836B71-760B-3417-5EAC-7FA3F2D7B8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343" y="1309552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6918343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008" y="127131"/>
            <a:ext cx="12015216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6386" name="Picture 2">
            <a:extLst>
              <a:ext uri="{FF2B5EF4-FFF2-40B4-BE49-F238E27FC236}">
                <a16:creationId xmlns:a16="http://schemas.microsoft.com/office/drawing/2014/main" id="{501B8243-2DFC-C41D-7334-9C484410CD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914" y="1167493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8" name="Picture 4">
            <a:extLst>
              <a:ext uri="{FF2B5EF4-FFF2-40B4-BE49-F238E27FC236}">
                <a16:creationId xmlns:a16="http://schemas.microsoft.com/office/drawing/2014/main" id="{E274CD1D-E0BB-F140-AD2A-7858413608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6114" y="1304653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944775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1026" name="Picture 2" descr="PCAScore2DImage">
            <a:extLst>
              <a:ext uri="{FF2B5EF4-FFF2-40B4-BE49-F238E27FC236}">
                <a16:creationId xmlns:a16="http://schemas.microsoft.com/office/drawing/2014/main" id="{A9623B93-DFC4-07BD-B3C3-3867602823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448" y="1107077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7E601384-7A54-DD1E-BCAB-00AC49D865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1798" y="1244237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843245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14497F64-0337-CFBE-9716-8E59152F2C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33" y="1147898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987F78C6-1AF5-0167-3384-0EE3C0E6B1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2760" y="1285058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24363836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0A31D208-CCF9-B0AC-881C-8FE648BA7C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96" y="1086934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>
            <a:extLst>
              <a:ext uri="{FF2B5EF4-FFF2-40B4-BE49-F238E27FC236}">
                <a16:creationId xmlns:a16="http://schemas.microsoft.com/office/drawing/2014/main" id="{F2F224A9-20E4-6E93-78CF-E4BA345E13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1993" y="1338394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9146103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13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7F028C3B-2D83-4572-19DC-4B4FB708B2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753" y="1160961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>
            <a:extLst>
              <a:ext uri="{FF2B5EF4-FFF2-40B4-BE49-F238E27FC236}">
                <a16:creationId xmlns:a16="http://schemas.microsoft.com/office/drawing/2014/main" id="{F7B61595-A900-4887-3898-3284F3F945F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1990" y="1326422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6693734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569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5122" name="Picture 2">
            <a:extLst>
              <a:ext uri="{FF2B5EF4-FFF2-40B4-BE49-F238E27FC236}">
                <a16:creationId xmlns:a16="http://schemas.microsoft.com/office/drawing/2014/main" id="{A9BB2323-4657-FADA-F22E-5F31EEF4FD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298448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>
            <a:extLst>
              <a:ext uri="{FF2B5EF4-FFF2-40B4-BE49-F238E27FC236}">
                <a16:creationId xmlns:a16="http://schemas.microsoft.com/office/drawing/2014/main" id="{3F4769C3-48FE-E82C-748E-3507510D2E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6483" y="1435608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3470936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569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6146" name="Picture 2">
            <a:extLst>
              <a:ext uri="{FF2B5EF4-FFF2-40B4-BE49-F238E27FC236}">
                <a16:creationId xmlns:a16="http://schemas.microsoft.com/office/drawing/2014/main" id="{348EAE8E-A9D7-3C50-D89D-6B83308FBB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603" y="1266770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>
            <a:extLst>
              <a:ext uri="{FF2B5EF4-FFF2-40B4-BE49-F238E27FC236}">
                <a16:creationId xmlns:a16="http://schemas.microsoft.com/office/drawing/2014/main" id="{A5B74DDE-1A38-210C-0835-D1ABFE2C0C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8514" y="1487748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2143811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483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1.0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id="{9EF5FDD3-132A-899E-63DD-E8AD56E16D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918" y="1330126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>
            <a:extLst>
              <a:ext uri="{FF2B5EF4-FFF2-40B4-BE49-F238E27FC236}">
                <a16:creationId xmlns:a16="http://schemas.microsoft.com/office/drawing/2014/main" id="{122F94F8-1DBA-8D2B-225F-F57F0F89FB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4648" y="1467286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569639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14F1DF-353F-CF63-1DA1-B8807495AD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290" y="552450"/>
            <a:ext cx="11361420" cy="5753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342712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356C4-E7CA-5512-CFBC-E46BA7F0F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569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2.1mm </a:t>
            </a:r>
            <a:r>
              <a:rPr lang="en-US" dirty="0" err="1"/>
              <a:t>i.d.</a:t>
            </a:r>
            <a:endParaRPr lang="en-US" dirty="0"/>
          </a:p>
        </p:txBody>
      </p:sp>
      <p:pic>
        <p:nvPicPr>
          <p:cNvPr id="8194" name="Picture 2">
            <a:extLst>
              <a:ext uri="{FF2B5EF4-FFF2-40B4-BE49-F238E27FC236}">
                <a16:creationId xmlns:a16="http://schemas.microsoft.com/office/drawing/2014/main" id="{DACFAFC0-C66E-30E2-FE31-69D8E76348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754" y="1313470"/>
            <a:ext cx="6172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>
            <a:extLst>
              <a:ext uri="{FF2B5EF4-FFF2-40B4-BE49-F238E27FC236}">
                <a16:creationId xmlns:a16="http://schemas.microsoft.com/office/drawing/2014/main" id="{A7ABD310-7A04-65F9-CC0B-45F77D81CB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3007" y="1450630"/>
            <a:ext cx="5349240" cy="5349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13691686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6 – RSD range for biological samples for each dilution, assay, sample type and column </a:t>
            </a:r>
            <a:r>
              <a:rPr lang="en-US" b="1" dirty="0" err="1"/>
              <a:t>i.d.</a:t>
            </a:r>
            <a:r>
              <a:rPr lang="en-US" b="1" dirty="0"/>
              <a:t> before performing blank and QC filtering</a:t>
            </a:r>
          </a:p>
        </p:txBody>
      </p:sp>
    </p:spTree>
    <p:extLst>
      <p:ext uri="{BB962C8B-B14F-4D97-AF65-F5344CB8AC3E}">
        <p14:creationId xmlns:p14="http://schemas.microsoft.com/office/powerpoint/2010/main" val="351910926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48FB317-8A23-1EDB-DE72-7A5DA22CC9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2025" y="428625"/>
            <a:ext cx="10267950" cy="600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9277432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4400" y="2646860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7 – The average number of reported compounds in human plasma and urine samples following a 1 in 4 dilution for each of three UHPLC-MS assays</a:t>
            </a:r>
            <a:br>
              <a:rPr lang="en-US" b="1" dirty="0"/>
            </a:br>
            <a:br>
              <a:rPr lang="en-US" b="1" dirty="0"/>
            </a:br>
            <a:r>
              <a:rPr lang="en-US" sz="3600" dirty="0"/>
              <a:t>Compounds which were present in 75% of replicates and had a relative standard deviation (RSD) &lt; 30% are reported. </a:t>
            </a:r>
            <a:br>
              <a:rPr lang="en-US" sz="3600" dirty="0"/>
            </a:br>
            <a:r>
              <a:rPr lang="en-US" sz="3600" dirty="0"/>
              <a:t>2.1mm ID column (green) and 1.0mm </a:t>
            </a:r>
            <a:r>
              <a:rPr lang="en-US" sz="3600" dirty="0" err="1"/>
              <a:t>i.d.</a:t>
            </a:r>
            <a:r>
              <a:rPr lang="en-US" sz="3600" dirty="0"/>
              <a:t> column (blue).</a:t>
            </a:r>
            <a:br>
              <a:rPr lang="en-US" sz="3600" dirty="0"/>
            </a:br>
            <a:br>
              <a:rPr lang="en-US" sz="3600" dirty="0"/>
            </a:br>
            <a:r>
              <a:rPr lang="en-US" sz="3600" dirty="0"/>
              <a:t>*** p &lt; 0.001</a:t>
            </a:r>
            <a:br>
              <a:rPr lang="en-US" sz="3600" dirty="0"/>
            </a:br>
            <a:r>
              <a:rPr lang="en-US" sz="3600" dirty="0"/>
              <a:t>** p &lt; 0.01</a:t>
            </a:r>
            <a:br>
              <a:rPr lang="en-US" sz="3600" dirty="0"/>
            </a:br>
            <a:r>
              <a:rPr lang="en-US" sz="3600" dirty="0"/>
              <a:t>* p &lt; 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3447481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6884344-924F-956B-1CB7-2A385512BB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0" y="361950"/>
            <a:ext cx="8839200" cy="6134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6443185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4400" y="2720012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8 – The number of reported compounds in human plasma and urine samples</a:t>
            </a:r>
            <a:br>
              <a:rPr lang="en-US" b="1" dirty="0"/>
            </a:br>
            <a:br>
              <a:rPr lang="en-US" b="1" dirty="0"/>
            </a:br>
            <a:r>
              <a:rPr lang="en-US" sz="3600" dirty="0"/>
              <a:t>Compounds were filtered so that only peaks with a peak width (FWHM) &lt; 0.2 minutes and which were present in 75% of replicate samples at each dilution and had a RSD &lt; 30% for each dilution remained.</a:t>
            </a:r>
            <a:br>
              <a:rPr lang="en-US" sz="3600" dirty="0"/>
            </a:br>
            <a:br>
              <a:rPr lang="en-US" sz="3600" dirty="0"/>
            </a:br>
            <a:r>
              <a:rPr lang="en-US" sz="3600" dirty="0"/>
              <a:t>*** p &lt; 0.001</a:t>
            </a:r>
            <a:br>
              <a:rPr lang="en-US" sz="3600" dirty="0"/>
            </a:br>
            <a:r>
              <a:rPr lang="en-US" sz="3600" dirty="0"/>
              <a:t>** p &lt; 0.01</a:t>
            </a:r>
            <a:br>
              <a:rPr lang="en-US" sz="3600" dirty="0"/>
            </a:br>
            <a:r>
              <a:rPr lang="en-US" sz="3600" dirty="0"/>
              <a:t>* p &lt; 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6800771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566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HILIC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39C6E6D-88BC-09F8-63FB-8D98F5E5BA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5125" y="1552194"/>
            <a:ext cx="8921750" cy="4714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4933484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994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HILIC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CB50B5-FB48-F837-3B4A-13B2F6A8D2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8250" y="1421130"/>
            <a:ext cx="7175500" cy="4905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0751332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566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LIPIDS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CE0C115-2AC7-A08B-678E-7CD5475700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5437" y="1284478"/>
            <a:ext cx="6461125" cy="5064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3603537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38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LIPIDS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7CF3BF0-AFF0-7919-D640-68A337159A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187" y="1248410"/>
            <a:ext cx="9699625" cy="5222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76863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842B7E5-7329-85A1-704F-280460405D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5175" y="479425"/>
            <a:ext cx="10661650" cy="5899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585836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738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HILIC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4CE39C2-D40C-8769-C331-64CBBB6CEE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1250" y="1364869"/>
            <a:ext cx="7429500" cy="5365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156768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128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HILIC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3D4F0BF-D755-5988-2F7A-98C8545EC4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5500" y="1366266"/>
            <a:ext cx="8001000" cy="4905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0380126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872" y="136525"/>
            <a:ext cx="11960352" cy="1325563"/>
          </a:xfrm>
        </p:spPr>
        <p:txBody>
          <a:bodyPr/>
          <a:lstStyle/>
          <a:p>
            <a:pPr algn="ctr"/>
            <a:r>
              <a:rPr lang="en-US" dirty="0"/>
              <a:t>Urine reversed phase aqueous nega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FCD44A-6133-32C0-F19C-587C8D995B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1562" y="1309624"/>
            <a:ext cx="7508875" cy="5207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908054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DE24-A25E-D43F-4BEA-B77913B15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9728" y="17653"/>
            <a:ext cx="11969496" cy="1325563"/>
          </a:xfrm>
        </p:spPr>
        <p:txBody>
          <a:bodyPr/>
          <a:lstStyle/>
          <a:p>
            <a:pPr algn="ctr"/>
            <a:r>
              <a:rPr lang="en-US" dirty="0"/>
              <a:t>Urine reversed phase aqueous positive ion mo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F639FC1-1013-4C5C-72AF-F2E172A648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4687" y="1144270"/>
            <a:ext cx="8302625" cy="5826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116038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44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9 – Summary table for the number of reported compounds for each sample dilution, assay, sample type and UHPLC column </a:t>
            </a:r>
            <a:r>
              <a:rPr lang="en-US" b="1" dirty="0" err="1"/>
              <a:t>i.d.</a:t>
            </a:r>
            <a:br>
              <a:rPr lang="en-US" b="1" dirty="0"/>
            </a:br>
            <a:br>
              <a:rPr lang="en-US" dirty="0"/>
            </a:br>
            <a:r>
              <a:rPr lang="en-US" sz="3600" dirty="0"/>
              <a:t>Compounds were filtered so that only peaks with a peak width (FWHM) &lt; 0.2 minutes and which were present in 75% of replicate samples in each dilution and had a RSD &lt; 30% for each dilution remained.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373887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2D592C0-C202-DE30-076E-A4737C4A7E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626601"/>
            <a:ext cx="7772400" cy="5604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1192548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0 – Summary table for peak width (FWHM, minutes) for each sample dilution, assay, sample type and UHPLC column </a:t>
            </a:r>
            <a:r>
              <a:rPr lang="en-US" b="1" dirty="0" err="1"/>
              <a:t>i.d.</a:t>
            </a:r>
            <a:br>
              <a:rPr lang="en-US" b="1" dirty="0"/>
            </a:br>
            <a:br>
              <a:rPr lang="en-US" dirty="0"/>
            </a:br>
            <a:r>
              <a:rPr lang="en-US" sz="3600" dirty="0"/>
              <a:t>Compounds were filtered so that only peaks with a RSD &lt; 30% for QC samples remained.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8635161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5FF0B8B-7E7B-69A3-F63D-F19B356714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3437" y="1907032"/>
            <a:ext cx="7985125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7351361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A70F1DC-1C24-B337-7C64-49EE48DC20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2812" y="1924050"/>
            <a:ext cx="7826375" cy="433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8601272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C8E4E95-81A1-ACF5-B5A4-270AD55F5A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9500" y="2042668"/>
            <a:ext cx="7493000" cy="396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6614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69761F2-7593-55CF-2B2A-0D0D9E94A2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882" y="243840"/>
            <a:ext cx="11532235" cy="6370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8905506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51A6457-BDB5-DA53-9885-CE3D294100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9812" y="1951736"/>
            <a:ext cx="7572375" cy="412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3582709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50C9258-3E06-C8CD-4E7B-ED0A418720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1875" y="1764792"/>
            <a:ext cx="758825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3839031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F6DFB5B-0AF0-50D9-EFB0-ECC31DE4C5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3625" y="1753744"/>
            <a:ext cx="7524750" cy="4476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8064803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88574C8-DAEB-E4FE-3034-3AAB40B306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6937" y="1996186"/>
            <a:ext cx="7858125" cy="4016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2745876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5C51D48-5F1B-3E14-D151-52C78E0A60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0" y="1906016"/>
            <a:ext cx="8128000" cy="412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7979769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BDAE9C6-1CE8-FE37-34BC-BE21260798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375" y="1867662"/>
            <a:ext cx="7715250" cy="4429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9948599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10566A-2239-24B4-F3EE-DA16378766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0" y="1872742"/>
            <a:ext cx="7620000" cy="4302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6911106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8051057-4007-DF3A-4690-3F1E4D9DD8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6812" y="1963674"/>
            <a:ext cx="7318375" cy="4143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3073830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8DCC33F-4268-2F4C-D531-9B6E5921E2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0625" y="1935734"/>
            <a:ext cx="7270750" cy="3984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3793523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Reversed phase aqueous nega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204FB7E-2D56-5468-F3B8-4936750667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6187" y="2039874"/>
            <a:ext cx="7159625" cy="3952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79387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C82636-9419-367C-3CC2-FD5A1669D8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822" y="296227"/>
            <a:ext cx="11476355" cy="6265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377686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Reversed phase aqueous nega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A82399-E20A-94B7-0219-7B1E8A617B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5375" y="2089150"/>
            <a:ext cx="7461250" cy="3921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4815348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Reversed phase aqueous posi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965F7E2-51CD-CB5E-87A3-CBC3F159DE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7750" y="1911604"/>
            <a:ext cx="7556500" cy="4159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3791105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rine / Reversed phase aqueous posi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941CB3A-CC00-7978-0815-CB83EAB4EA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9812" y="2072894"/>
            <a:ext cx="7572375" cy="3984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5163423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90C94-19A4-A2FB-0783-749CA4526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4400" y="3049196"/>
            <a:ext cx="105156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/>
              <a:t>S11 – Distribution of peak widths in relation to retention time for each sample dilution, assay, sample type and UHPLC column </a:t>
            </a:r>
            <a:r>
              <a:rPr lang="en-US" b="1" dirty="0" err="1"/>
              <a:t>i.d.</a:t>
            </a:r>
            <a:br>
              <a:rPr lang="en-US" dirty="0"/>
            </a:br>
            <a:br>
              <a:rPr lang="en-US" dirty="0"/>
            </a:br>
            <a:r>
              <a:rPr lang="en-US" sz="3600" dirty="0"/>
              <a:t>Compounds were filtered so that only peaks with a a RSD &lt; 30% for QC samples remained.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1701133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994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79E9F62-184C-1F00-0DF7-424C1E9440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750" y="1605026"/>
            <a:ext cx="8572500" cy="5153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97619"/>
      </p:ext>
    </p:extLst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080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65F877D-12B3-C870-4D53-739D08538D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0970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2522858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7251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9D1234C-1556-AB71-C381-6E3576D722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39808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0554564"/>
      </p:ext>
    </p:extLst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080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E866318-F0EF-742B-7E40-370BBD87BC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0970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771686"/>
      </p:ext>
    </p:extLst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10860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3BCCA5F-E2BB-CFC2-312A-64033A8E01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3417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6725582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994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D23BC57-75CD-2DC6-8363-C469C2282F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00556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91489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670F276-550E-7CE3-91B7-6C86AED144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240" y="729297"/>
            <a:ext cx="11399520" cy="5399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974766"/>
      </p:ext>
    </p:extLst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3373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40D1D0B-3ACB-4D19-756E-888D60C8E3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388936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62312"/>
      </p:ext>
    </p:extLst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080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Plasma / </a:t>
            </a:r>
            <a:r>
              <a:rPr lang="en-US" dirty="0" err="1"/>
              <a:t>Lipidomics</a:t>
            </a:r>
            <a:r>
              <a:rPr lang="en-US" dirty="0"/>
              <a:t>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AA0F2F1-876B-F4B1-75B0-AA339370F2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3417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4223199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8166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3DDEA1F-B8E3-F28A-B8F7-05F78961F1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8300" y="1407224"/>
            <a:ext cx="8915400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363224"/>
      </p:ext>
    </p:extLst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7251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nega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FABB49-67B3-A7FC-C9DA-8894081071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39808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32251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10291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1602998-3FEF-1DA3-F66D-42C9803373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397594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9769617"/>
      </p:ext>
    </p:extLst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09093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HILIC positive ion mode </a:t>
            </a:r>
            <a:br>
              <a:rPr lang="en-US" dirty="0"/>
            </a:br>
            <a:r>
              <a:rPr lang="en-US" dirty="0"/>
              <a:t>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8498903-12BA-7F5F-F944-5910CC2518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34656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2432443"/>
      </p:ext>
    </p:extLst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81661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4DF9D31-54DF-360E-1EC5-B68E85C661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8300" y="1413722"/>
            <a:ext cx="8915400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6073948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91440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nega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1431440-848A-7D81-CC45-1CB75AEF19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09065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5038347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9031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1.0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0410A39-7CA8-3ACE-3212-B27313FDA8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415882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4091595"/>
      </p:ext>
    </p:extLst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1F6E-E64C-BDDC-A472-4097D5CC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72517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Urine / Reversed phase aqueous positive ion mode / 2.1mm </a:t>
            </a:r>
            <a:r>
              <a:rPr lang="en-US" dirty="0" err="1"/>
              <a:t>i.d.</a:t>
            </a:r>
            <a:r>
              <a:rPr lang="en-US" dirty="0"/>
              <a:t> colum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CD9FEAC-9B80-2229-98AC-80F517DE8F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172" y="1398080"/>
            <a:ext cx="8923655" cy="5357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6866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1869</Words>
  <Application>Microsoft Macintosh PowerPoint</Application>
  <PresentationFormat>Widescreen</PresentationFormat>
  <Paragraphs>109</Paragraphs>
  <Slides>1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5</vt:i4>
      </vt:variant>
    </vt:vector>
  </HeadingPairs>
  <TitlesOfParts>
    <vt:vector size="130" baseType="lpstr">
      <vt:lpstr>Arial</vt:lpstr>
      <vt:lpstr>Arno Pro</vt:lpstr>
      <vt:lpstr>Calibri</vt:lpstr>
      <vt:lpstr>Calibri Light</vt:lpstr>
      <vt:lpstr>Office Theme</vt:lpstr>
      <vt:lpstr>SUPPLEMENTARY INFORMATION FILES   Development of Microflow Ultra High Performance Liquid Chromatography -Mass Spectrometry Metabolomic Assays for Analysis of Mammalian Biofluids     Annie J. Harwood-Stamper1, Caroline A. Rowland2, and Warwick B. Dunn1,3   1 School of Biosciences, University of Birmingham, Edgbaston, Birmingham, B15 2TT, UK 2 Defence Science and Technology Laboratory, Porton Down, Salisbury, SP4 0JQ, UK 3 Centre for Metabolomics Research, Department of Biochemistry, Cell and Systems Biology, Institute of Systems, Molecular and Integrative Biology, University of Liverpool, Biosciences Building, Crown Street, Liverpool, L69 7ZB, UK </vt:lpstr>
      <vt:lpstr>S1 – Serial dilution calculations  and volumes applied</vt:lpstr>
      <vt:lpstr>PowerPoint Presentation</vt:lpstr>
      <vt:lpstr>S2 – Compound Discoverer v3.0 workflow and parameters applied to analyse data acquired  for human sampl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3 – Compound Discoverer v3.1 workflow and parameters applied to analyse data acquired  for porcine sampl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4 – Base Peak Ion Chromatograms for each assay, sample type and UHPLC column i.d. for 1 in 4 dilution data</vt:lpstr>
      <vt:lpstr>Plasma / HILIC negative ion mode  / 1.0mm i.d. column</vt:lpstr>
      <vt:lpstr>Plasma / HILIC negative ion mode  / 2.1mm i.d. column</vt:lpstr>
      <vt:lpstr>Plasma / HILIC positive ion mode  / 1.0mm i.d. column</vt:lpstr>
      <vt:lpstr>Plasma / HILIC positive ion mode  / 2.1mm i.d. column</vt:lpstr>
      <vt:lpstr>Plasma / Lipidomics negative ion mode  / 1.0mm i.d. column</vt:lpstr>
      <vt:lpstr>Plasma / Lipidomics negative ion mode  / 2.1mm i.d. column</vt:lpstr>
      <vt:lpstr>Plasma / Lipidomics positive ion mode  / 1.0mm i.d. column</vt:lpstr>
      <vt:lpstr>Plasma / Lipidomics positive ion mode  / 2.1mm i.d. column</vt:lpstr>
      <vt:lpstr>Urine / HILIC negative ion mode  / 1.0mm i.d. column</vt:lpstr>
      <vt:lpstr>Urine / HILIC negative ion mode  / 2.1mm i.d. column</vt:lpstr>
      <vt:lpstr>Urine / HILIC positive ion mode  / 1.0mm i.d. column</vt:lpstr>
      <vt:lpstr>Urine / HILIC positive ion mode  / 2.1mm i.d. column</vt:lpstr>
      <vt:lpstr>Urine / reversed phase aqueous negative ion mode / 1.0mm i.d. column</vt:lpstr>
      <vt:lpstr>Urine / reversed phase aqueous negative ion mode / 2.1mm i.d. column</vt:lpstr>
      <vt:lpstr>Urine / reversed phase aqueous positive ion mode / 1.0mm i.d. column</vt:lpstr>
      <vt:lpstr>Urine / reversed phase aqueous positive ion mode / 2.1mm i.d. column</vt:lpstr>
      <vt:lpstr>S5 – PCA scores and loading plots applied to assess data variability and differences related to sample dilution for each assay, sample type and UHPLC column i.d.</vt:lpstr>
      <vt:lpstr>Plasma / HILIC negative ion mode / 1.0mm i.d.</vt:lpstr>
      <vt:lpstr>Plasma / HILIC negative ion mode / 2.1mm i.d.</vt:lpstr>
      <vt:lpstr>Plasma / HILIC positive ion mode / 1.0mm i.d.</vt:lpstr>
      <vt:lpstr>Plasma / HILIC positive ion mode / 2.1mm i.d.</vt:lpstr>
      <vt:lpstr>Plasma / Lipidomics negative ion mode / 1.0mm i.d.</vt:lpstr>
      <vt:lpstr>Plasma / Lipidomics negative ion mode / 2.1mm i.d.</vt:lpstr>
      <vt:lpstr>Plasma / Lipidomics positive ion mode / 1.0mm i.d.</vt:lpstr>
      <vt:lpstr>Plasma / Lipidomics positive ion mode / 2.1mm i.d.</vt:lpstr>
      <vt:lpstr>Urine / HILIC negative ion mode / 1.0mm i.d.</vt:lpstr>
      <vt:lpstr>Urine / HILIC negative ion mode / 2.1mm i.d.</vt:lpstr>
      <vt:lpstr>Urine / HILIC positive ion mode / 1.0mm i.d.</vt:lpstr>
      <vt:lpstr>Urine / HILIC positive ion mode / 2.1mm i.d.</vt:lpstr>
      <vt:lpstr>Urine / reversed phase aqueous negative ion mode / 1.0mm i.d.</vt:lpstr>
      <vt:lpstr>Urine / reversed phase aqueous negative ion mode / 2.1mm i.d.</vt:lpstr>
      <vt:lpstr>Urine / reversed phase aqueous positive ion mode / 1.0mm i.d.</vt:lpstr>
      <vt:lpstr>Urine / reversed phase aqueous positive ion mode / 2.1mm i.d.</vt:lpstr>
      <vt:lpstr>S6 – RSD range for biological samples for each dilution, assay, sample type and column i.d. before performing blank and QC filtering</vt:lpstr>
      <vt:lpstr>PowerPoint Presentation</vt:lpstr>
      <vt:lpstr>S7 – The average number of reported compounds in human plasma and urine samples following a 1 in 4 dilution for each of three UHPLC-MS assays  Compounds which were present in 75% of replicates and had a relative standard deviation (RSD) &lt; 30% are reported.  2.1mm ID column (green) and 1.0mm i.d. column (blue).  *** p &lt; 0.001 ** p &lt; 0.01 * p &lt; 0.05</vt:lpstr>
      <vt:lpstr>PowerPoint Presentation</vt:lpstr>
      <vt:lpstr>S8 – The number of reported compounds in human plasma and urine samples  Compounds were filtered so that only peaks with a peak width (FWHM) &lt; 0.2 minutes and which were present in 75% of replicate samples at each dilution and had a RSD &lt; 30% for each dilution remained.  *** p &lt; 0.001 ** p &lt; 0.01 * p &lt; 0.05</vt:lpstr>
      <vt:lpstr>Plasma HILIC negative ion mode</vt:lpstr>
      <vt:lpstr>Plasma HILIC positive ion mode</vt:lpstr>
      <vt:lpstr>Plasma LIPIDS negative ion mode</vt:lpstr>
      <vt:lpstr>Plasma LIPIDS positive ion mode</vt:lpstr>
      <vt:lpstr>Urine HILIC negative ion mode</vt:lpstr>
      <vt:lpstr>Urine HILIC positive ion mode</vt:lpstr>
      <vt:lpstr>Urine reversed phase aqueous negative ion mode</vt:lpstr>
      <vt:lpstr>Urine reversed phase aqueous positive ion mode</vt:lpstr>
      <vt:lpstr>S9 – Summary table for the number of reported compounds for each sample dilution, assay, sample type and UHPLC column i.d.  Compounds were filtered so that only peaks with a peak width (FWHM) &lt; 0.2 minutes and which were present in 75% of replicate samples in each dilution and had a RSD &lt; 30% for each dilution remained. </vt:lpstr>
      <vt:lpstr>PowerPoint Presentation</vt:lpstr>
      <vt:lpstr>S10 – Summary table for peak width (FWHM, minutes) for each sample dilution, assay, sample type and UHPLC column i.d.  Compounds were filtered so that only peaks with a RSD &lt; 30% for QC samples remained. </vt:lpstr>
      <vt:lpstr>Plasma / HILIC negative ion mode  / 1.0mm i.d. column</vt:lpstr>
      <vt:lpstr>Plasma / HILIC negative ion mode  / 2.1mm i.d. column</vt:lpstr>
      <vt:lpstr>Plasma / HILIC positive ion mode  / 1.0mm i.d. column</vt:lpstr>
      <vt:lpstr>Plasma / HILIC positive ion mode  / 2.1mm i.d. column</vt:lpstr>
      <vt:lpstr>Plasma / Lipidomics negative ion mode  / 1.0mm i.d. column</vt:lpstr>
      <vt:lpstr>Plasma / Lipidomics negative ion mode  / 2.1mm i.d. column</vt:lpstr>
      <vt:lpstr>Plasma / Lipidomics positive ion mode  / 1.0mm i.d. column</vt:lpstr>
      <vt:lpstr>Plasma / Lipidomics positive ion mode  / 2.1mm i.d. column</vt:lpstr>
      <vt:lpstr>Urine / HILIC negative ion mode  / 1.0mm i.d. column</vt:lpstr>
      <vt:lpstr>Urine / HILIC negative ion mode  / 2.1mm i.d. column</vt:lpstr>
      <vt:lpstr>Urine / HILIC positive ion mode  / 1.0mm i.d. column</vt:lpstr>
      <vt:lpstr>Urine / HILIC positive ion mode  / 2.1mm i.d. column</vt:lpstr>
      <vt:lpstr>Urine / Reversed phase aqueous negative ion mode / 1.0mm i.d. column</vt:lpstr>
      <vt:lpstr>Urine / Reversed phase aqueous negative ion mode / 2.1mm i.d. column</vt:lpstr>
      <vt:lpstr>Urine / Reversed phase aqueous positive ion mode / 1.0mm i.d. column</vt:lpstr>
      <vt:lpstr>Urine / Reversed phase aqueous positive ion mode / 2.1mm i.d. column</vt:lpstr>
      <vt:lpstr>S11 – Distribution of peak widths in relation to retention time for each sample dilution, assay, sample type and UHPLC column i.d.  Compounds were filtered so that only peaks with a a RSD &lt; 30% for QC samples remained.  </vt:lpstr>
      <vt:lpstr>Plasma / HILIC negative ion mode  / 1.0mm i.d. column</vt:lpstr>
      <vt:lpstr>Plasma / HILIC negative ion mode  / 2.1mm i.d. column</vt:lpstr>
      <vt:lpstr>Plasma / HILIC positive ion mode  / 1.0mm i.d. column</vt:lpstr>
      <vt:lpstr>Plasma / HILIC positive ion mode  / 2.1mm i.d. column</vt:lpstr>
      <vt:lpstr>Plasma / Lipidomics negative ion mode  / 1.0mm i.d. column</vt:lpstr>
      <vt:lpstr>Plasma / Lipidomics negative ion mode  / 2.1mm i.d. column</vt:lpstr>
      <vt:lpstr>Plasma / Lipidomics positive ion mode  / 1.0mm i.d. column</vt:lpstr>
      <vt:lpstr>Plasma / Lipidomics positive ion mode  / 2.1mm i.d. column</vt:lpstr>
      <vt:lpstr>Urine / HILIC negative ion mode  / 1.0mm i.d. column</vt:lpstr>
      <vt:lpstr>Urine / HILIC negative ion mode  / 2.1mm i.d. column</vt:lpstr>
      <vt:lpstr>Urine / HILIC positive ion mode  / 1.0mm i.d. column</vt:lpstr>
      <vt:lpstr>Urine / HILIC positive ion mode  / 2.1mm i.d. column</vt:lpstr>
      <vt:lpstr>Urine / Reversed phase aqueous negative ion mode / 1.0mm i.d. column</vt:lpstr>
      <vt:lpstr>Urine / Reversed phase aqueous negative ion mode / 2.1mm i.d. column</vt:lpstr>
      <vt:lpstr>Urine / Reversed phase aqueous positive ion mode / 1.0mm i.d. column</vt:lpstr>
      <vt:lpstr>Urine / Reversed phase aqueous positive ion mode / 2.1mm i.d. column</vt:lpstr>
      <vt:lpstr>S12 – Distribution of peak width (FWHM, minutes) for each sample dilution, assay, sample type  and UHPLC column i.d.  Compounds were filtered so that only peaks with a RSD &lt; 30% for QC samples remained.  *** p &lt; 0.001 ** p&lt; 0.01 * p&lt; 0.05    </vt:lpstr>
      <vt:lpstr>Plasma / HILIC negative ion mode</vt:lpstr>
      <vt:lpstr>Plasma / HILIC positive ion mode</vt:lpstr>
      <vt:lpstr>Plasma / Lipidomics negative ion mode</vt:lpstr>
      <vt:lpstr>Plasma / Lipidomics positive ion mode</vt:lpstr>
      <vt:lpstr>Urine / HILIC negative ion mode</vt:lpstr>
      <vt:lpstr>Urine / HILIC positive ion mode</vt:lpstr>
      <vt:lpstr>Urine / Reversed phase aqueous negative ion mode</vt:lpstr>
      <vt:lpstr>Urine / Reversed phase aqueous positive ion mode</vt:lpstr>
      <vt:lpstr>S13 – Distribution of chromatographic peak areas for each sample dilution, assay, sample type  and UHPLC column i.d.  Compounds were filtered so that only peaks with a RSD &lt; 30% for QC samples remained.  *** p &lt; 0.001 ** p &lt; 0.01 * p &lt; 0.05  </vt:lpstr>
      <vt:lpstr>Plasma / HILIC negative ion mode</vt:lpstr>
      <vt:lpstr>Plasma / HILIC positive ion mode</vt:lpstr>
      <vt:lpstr>Plasma / Lipidomics negative ion mode</vt:lpstr>
      <vt:lpstr>Plasma / Lipidomics positive ion mode</vt:lpstr>
      <vt:lpstr>Urine / HILIC negative ion mode</vt:lpstr>
      <vt:lpstr>Urine / HILIC positive ion mode</vt:lpstr>
      <vt:lpstr>Urine / Reversed phase aqueous negative ion mode</vt:lpstr>
      <vt:lpstr>Urine / Reversed phase aqueous positive ion mode</vt:lpstr>
      <vt:lpstr>S14 – Distribution of chromatographic peak areas for the 1 in 16 dilution of each assay type for both the 2.1mm id (blue) and 1.0mm id (red)  Compounds were filtered so that only peaks with a RSD &lt; 30% for QC samples remained.  *** p &lt; 0.001 ** p &lt; 0.01 * p &lt; 0.05  </vt:lpstr>
      <vt:lpstr>PowerPoint Presentation</vt:lpstr>
      <vt:lpstr>S15 – Overlap of annotated metabolites for porcine plasma (red) and porcine tear fluid (blue) </vt:lpstr>
      <vt:lpstr>Lipids negative ion mode</vt:lpstr>
      <vt:lpstr>Lipids positive ion mode</vt:lpstr>
      <vt:lpstr>S16 – Overlap of annotated metabolites for porcine urine (red) and porcine tear fluid (blue)  </vt:lpstr>
      <vt:lpstr>Reversed phase aqueous negative ion mode</vt:lpstr>
      <vt:lpstr>Reversed phase aqueous positive ion mod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INFORMATION FILES   Development of Microflow Ultra High Performance Liquid Chromatography -Mass Spectrometry Metabolomic Assays for Analysis of Mammalian Biofluids     Annie J. Harwood-Stamper1, Caroline A. Rowland2, and Warwick B. Dunn1,3   1 School of Biosciences, University of Birmingham, Edgbaston, Birmingham, B15 2TT, UK 2 Defence Science and Technology Laboratory, Porton Down, Salisbury, SP4 0JQ, UK 3 Centre for Metabolomics Research, Department of Biochemistry, Cell and Systems Biology, Institute of Systems, Molecular and Integrative Biology, University of Liverpool, Biosciences Building, Crown Street, Liverpool, L69 7ZB, UK </dc:title>
  <dc:creator>Dunn, Warwick</dc:creator>
  <cp:lastModifiedBy>Dunn, Warwick</cp:lastModifiedBy>
  <cp:revision>18</cp:revision>
  <dcterms:created xsi:type="dcterms:W3CDTF">2024-02-29T11:21:25Z</dcterms:created>
  <dcterms:modified xsi:type="dcterms:W3CDTF">2024-02-29T20:01:51Z</dcterms:modified>
</cp:coreProperties>
</file>